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65" r:id="rId3"/>
    <p:sldId id="266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003"/>
    <p:restoredTop sz="96395"/>
  </p:normalViewPr>
  <p:slideViewPr>
    <p:cSldViewPr snapToGrid="0">
      <p:cViewPr varScale="1">
        <p:scale>
          <a:sx n="128" d="100"/>
          <a:sy n="128" d="100"/>
        </p:scale>
        <p:origin x="192" y="2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98A538-0DF1-9DFB-F00D-1DF71086C0A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B02B000-40A9-699A-B46F-3F0E0FA552B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319892-F9F2-2FC0-1AAB-BD1F2AB81A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20DCA-0B9C-164A-BCF4-9D2D39213BCD}" type="datetimeFigureOut">
              <a:rPr lang="en-US" smtClean="0"/>
              <a:t>3/7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733DD3-BA40-24E7-0BEE-E7EB8EB57D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518138-B1CE-3B0D-8152-1949196D76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0FB73-DA3B-5246-AA79-B6173953CD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6951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E2B96B-2DA1-C2FD-99D7-CA78CC7B63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4505E6D-4463-B06A-C6F6-38938BB6FE5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6B134E-34AB-2C43-4F63-A1F8850258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20DCA-0B9C-164A-BCF4-9D2D39213BCD}" type="datetimeFigureOut">
              <a:rPr lang="en-US" smtClean="0"/>
              <a:t>3/7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CDA34E-CCDF-6321-DCDF-C9F77CF5AD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E03411-B392-660B-74D7-C376620863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0FB73-DA3B-5246-AA79-B6173953CD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61538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0731263-4C78-BBC4-CC76-32B7CF8B9BD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F2CEE1B-4E6B-08ED-57EE-74F3592125C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9C7313-2ABE-EDB7-7867-9D95B18BDD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20DCA-0B9C-164A-BCF4-9D2D39213BCD}" type="datetimeFigureOut">
              <a:rPr lang="en-US" smtClean="0"/>
              <a:t>3/7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BAB74F-AC5D-809C-DFC0-6242CBB7CC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82201A-E766-57D3-49B7-DEDE52A282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0FB73-DA3B-5246-AA79-B6173953CD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45137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360214-8137-3386-E320-D7B7D6AE16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ED785D9-30FB-E167-6C18-01A0D00ADE3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D02AEF9-A01B-D6B4-0B46-F77960B4CA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20DCA-0B9C-164A-BCF4-9D2D39213BCD}" type="datetimeFigureOut">
              <a:rPr lang="en-US" smtClean="0"/>
              <a:t>3/7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DDDE11-2442-0FCD-4A5D-7C83CCF2BB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62055B-42D5-DCE0-6116-71E66486FB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0FB73-DA3B-5246-AA79-B6173953CD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53642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62443D-0007-836D-C441-BFE484638E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7E80590-9D5D-AD59-C903-4C3447003C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E07B65-61D8-4A64-1AFE-BD35755992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20DCA-0B9C-164A-BCF4-9D2D39213BCD}" type="datetimeFigureOut">
              <a:rPr lang="en-US" smtClean="0"/>
              <a:t>3/7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B67DEF-9C0F-CE2C-82A4-71823FFDCF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1CE5E4-3AA0-FF1B-7C99-CE3B0993AA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0FB73-DA3B-5246-AA79-B6173953CD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0764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554FCF-7111-BC92-D8A5-394A06E151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D3E976E-D2E7-B8B5-27A9-9610E2477C4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939CC51-82DB-D444-3F20-06900D2F63C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5AEFA7E-0D20-2DD3-7AB9-DD72379343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20DCA-0B9C-164A-BCF4-9D2D39213BCD}" type="datetimeFigureOut">
              <a:rPr lang="en-US" smtClean="0"/>
              <a:t>3/7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A8B16A6-BD6A-BEDA-B604-A8ED561946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C2BCB5-85BA-E84C-79BB-97A8A46987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0FB73-DA3B-5246-AA79-B6173953CD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72595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1CD2EE-B78E-0229-4416-37708018F2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19A6B13-3F93-8A16-EDF4-A4C6A2ED7A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176E404-7150-C340-79E7-F9AAA2C6C56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E183173-56F5-8A2A-0D65-F19658C7232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768E1A1-4720-409F-2F51-C8A96C55825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7D9B651-DED8-25E4-7C69-B1F80F7221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20DCA-0B9C-164A-BCF4-9D2D39213BCD}" type="datetimeFigureOut">
              <a:rPr lang="en-US" smtClean="0"/>
              <a:t>3/7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66B5FFC-D8FE-A31C-3A68-D6D585F789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EB354DF-DE65-6480-9A9F-5E3E364394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0FB73-DA3B-5246-AA79-B6173953CD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92561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D572DB-E7BE-17E4-A1C4-05D708AE92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DF15B70-6A18-61D1-1732-9395431190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20DCA-0B9C-164A-BCF4-9D2D39213BCD}" type="datetimeFigureOut">
              <a:rPr lang="en-US" smtClean="0"/>
              <a:t>3/7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1462E02-93FE-A567-7571-E8B3497921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7102CBF-F9F1-CDDE-CBCA-79102E9EF3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0FB73-DA3B-5246-AA79-B6173953CD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74174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A1F928D-19B5-77F5-7A2A-0872D46808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20DCA-0B9C-164A-BCF4-9D2D39213BCD}" type="datetimeFigureOut">
              <a:rPr lang="en-US" smtClean="0"/>
              <a:t>3/7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BF52A21-CF5B-67E5-5ADB-92C78F3D31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F76BD55-173B-6A4F-F6D0-A3EB699387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0FB73-DA3B-5246-AA79-B6173953CD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7126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B127C0-EA1F-3697-B89D-8B9C44019F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7C41D43-9A59-9BE0-DDFF-64CFAC78A37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AD0CEEF-69B1-93B2-29C2-D7E51222467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6C3E3BD-2BD5-2339-C7D8-E8E78AB492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20DCA-0B9C-164A-BCF4-9D2D39213BCD}" type="datetimeFigureOut">
              <a:rPr lang="en-US" smtClean="0"/>
              <a:t>3/7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BD1E7C8-46D3-1BFD-1E6B-3D3CDD85D3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5B72A50-6358-DD76-12BE-60C36B6B4A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0FB73-DA3B-5246-AA79-B6173953CD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511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E00E5C-F07A-4569-1594-E391C488F6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9DC4C81-8739-AB01-EB10-E7679D8CB4E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B20B4AB-2124-1727-FC16-BF4A00629F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CC5C98E-7A8F-E59F-661B-F409061394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20DCA-0B9C-164A-BCF4-9D2D39213BCD}" type="datetimeFigureOut">
              <a:rPr lang="en-US" smtClean="0"/>
              <a:t>3/7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259D03E-9155-A5A4-F31B-BAD153A467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B12583C-9407-8E20-C336-6D21121B9C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0FB73-DA3B-5246-AA79-B6173953CD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90750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69450C6-9440-1682-CFAF-F06B354705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CCACECC-B7F9-E819-87D6-EA02DED378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BA89D8-2223-AF4C-3798-F191336603A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A20DCA-0B9C-164A-BCF4-9D2D39213BCD}" type="datetimeFigureOut">
              <a:rPr lang="en-US" smtClean="0"/>
              <a:t>3/7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6EB318-05FF-057B-2F37-C5381382F34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546F04-C74A-6A15-2792-820DB8D657C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80FB73-DA3B-5246-AA79-B6173953CD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32754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C7ABC98F-7831-AB53-A1ED-317037526913}"/>
              </a:ext>
            </a:extLst>
          </p:cNvPr>
          <p:cNvSpPr txBox="1"/>
          <p:nvPr/>
        </p:nvSpPr>
        <p:spPr>
          <a:xfrm>
            <a:off x="79194" y="1997839"/>
            <a:ext cx="1845377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ull diagram</a:t>
            </a:r>
          </a:p>
          <a:p>
            <a:endParaRPr lang="en-US" dirty="0"/>
          </a:p>
          <a:p>
            <a:r>
              <a:rPr lang="en-US" dirty="0"/>
              <a:t>White box with green text = rationale</a:t>
            </a:r>
          </a:p>
          <a:p>
            <a:endParaRPr lang="en-US" dirty="0"/>
          </a:p>
          <a:p>
            <a:r>
              <a:rPr lang="en-US" dirty="0"/>
              <a:t>White box with black text = implementation strategy</a:t>
            </a:r>
          </a:p>
        </p:txBody>
      </p:sp>
      <p:pic>
        <p:nvPicPr>
          <p:cNvPr id="3" name="Picture 2" descr="A diagram of a company&#10;&#10;Description automatically generated">
            <a:extLst>
              <a:ext uri="{FF2B5EF4-FFF2-40B4-BE49-F238E27FC236}">
                <a16:creationId xmlns:a16="http://schemas.microsoft.com/office/drawing/2014/main" id="{43690DF1-46C5-B221-405F-FB4E78350CD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24571" y="0"/>
            <a:ext cx="9183401" cy="68555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89171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4D79BE2-6735-960E-DF08-FF73D9DD133E}"/>
              </a:ext>
            </a:extLst>
          </p:cNvPr>
          <p:cNvSpPr txBox="1"/>
          <p:nvPr/>
        </p:nvSpPr>
        <p:spPr>
          <a:xfrm>
            <a:off x="4993304" y="395728"/>
            <a:ext cx="199163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op half of diagram</a:t>
            </a:r>
          </a:p>
          <a:p>
            <a:endParaRPr lang="en-US" dirty="0"/>
          </a:p>
        </p:txBody>
      </p:sp>
      <p:pic>
        <p:nvPicPr>
          <p:cNvPr id="4" name="Picture 3" descr="A diagram of a company&#10;&#10;Description automatically generated">
            <a:extLst>
              <a:ext uri="{FF2B5EF4-FFF2-40B4-BE49-F238E27FC236}">
                <a16:creationId xmlns:a16="http://schemas.microsoft.com/office/drawing/2014/main" id="{3322D2BA-5E72-A705-D821-8DB4D93A088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8836" y="1042059"/>
            <a:ext cx="10954328" cy="51905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094088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44F9B090-B0B1-CE96-A650-A7B39B1F313C}"/>
              </a:ext>
            </a:extLst>
          </p:cNvPr>
          <p:cNvSpPr txBox="1"/>
          <p:nvPr/>
        </p:nvSpPr>
        <p:spPr>
          <a:xfrm>
            <a:off x="4917151" y="199785"/>
            <a:ext cx="235769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ottom half of diagram</a:t>
            </a:r>
          </a:p>
          <a:p>
            <a:endParaRPr lang="en-US" dirty="0"/>
          </a:p>
        </p:txBody>
      </p:sp>
      <p:pic>
        <p:nvPicPr>
          <p:cNvPr id="5" name="Picture 4" descr="A diagram of a company&#10;&#10;Description automatically generated">
            <a:extLst>
              <a:ext uri="{FF2B5EF4-FFF2-40B4-BE49-F238E27FC236}">
                <a16:creationId xmlns:a16="http://schemas.microsoft.com/office/drawing/2014/main" id="{0DA21AF9-E860-9164-D421-71023857CBA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472" y="1330109"/>
            <a:ext cx="12151528" cy="40729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932988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78</TotalTime>
  <Words>25</Words>
  <Application>Microsoft Macintosh PowerPoint</Application>
  <PresentationFormat>Widescreen</PresentationFormat>
  <Paragraphs>7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njamin Jones</dc:creator>
  <cp:lastModifiedBy>Benjamin Jones</cp:lastModifiedBy>
  <cp:revision>2</cp:revision>
  <dcterms:created xsi:type="dcterms:W3CDTF">2023-08-11T20:28:56Z</dcterms:created>
  <dcterms:modified xsi:type="dcterms:W3CDTF">2024-03-08T02:55:13Z</dcterms:modified>
</cp:coreProperties>
</file>